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597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4417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34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098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541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760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8589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3634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023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560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485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1A34F-8C99-41BB-8265-D04D695A376E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B3251-BD70-407A-8915-FF18A5B2DEB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155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4052" y="381622"/>
            <a:ext cx="6838121" cy="5144536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344557" y="5721246"/>
            <a:ext cx="11529390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7.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asting phenotype for seed size displayed by the Cluster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WM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cession MG55 (a) and the Cluster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M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cession MG170 (b)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370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DZ-Forum.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4</cp:revision>
  <dcterms:created xsi:type="dcterms:W3CDTF">2019-04-29T13:24:26Z</dcterms:created>
  <dcterms:modified xsi:type="dcterms:W3CDTF">2019-07-31T07:42:44Z</dcterms:modified>
</cp:coreProperties>
</file>